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6" r:id="rId4"/>
    <p:sldId id="268" r:id="rId5"/>
    <p:sldId id="274" r:id="rId6"/>
    <p:sldId id="275" r:id="rId7"/>
    <p:sldId id="267" r:id="rId8"/>
    <p:sldId id="27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thy Tang" initials="CT" lastIdx="0" clrIdx="0">
    <p:extLst>
      <p:ext uri="{19B8F6BF-5375-455C-9EA6-DF929625EA0E}">
        <p15:presenceInfo xmlns:p15="http://schemas.microsoft.com/office/powerpoint/2012/main" userId="1319e8b0bf57407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8A93C-6162-417F-9D65-FA6281DA87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E4B3D1-BF5B-493E-8078-A909C1D4CF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DA861-0560-4CE6-BAAF-84DF250C0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FCC34-2518-445F-84A4-F3C2CD8C0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68A9A7-8E5F-46AE-9491-E655A889E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25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77884B-DE85-47AA-9336-C9184AF98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97628A-B0E9-4B5B-8B85-D7823B5151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B5BD26-59F2-4D58-B375-161F31E0F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D52AA7-0422-4C15-8CDC-7290B6D4D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80415-509F-4344-B6D9-091B2DC3B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7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E350FB-6678-4B7B-AB0F-3405D37C67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956F3C-7D5B-4D40-809B-5B88A78CAB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02FE10-BE5F-4290-A643-47773C04E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1DB9C0-C394-44FE-AB3B-D01A7B734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17991-B51F-4118-9F19-116EF2D74D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800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6E9C1-30C0-46E3-813B-4BB411712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C8A0CA-31CC-4BBB-B6B0-9D2E12CC28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7B2014-A3C3-4D6E-B4D9-7C005A044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6ABD1-5DED-4016-9225-3B8E05551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9B3945-5F17-41A2-A550-E3A9F56BF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159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BB210-346C-4E71-9697-5A55E69EC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14FE88-5DB6-4F44-B6AD-DE71CECB41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474D89-596A-451D-9244-65A33EAF8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3E77C-7D21-4F1F-AC01-BBCFDFC4F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22679E-FC19-4752-8423-2E1C4C5F3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942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CCE8A-BCB2-41B9-A3E9-489B15C25F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C028DA-B8E4-46C3-9927-707A124D04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3E41B4-1AA6-49C9-8E04-2C1202CBE7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C1D96E-8ABD-414C-8A3C-6D7968857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15DDBD-2D66-4C41-B2E1-21C382F06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08C5EF-F61A-4864-8AD0-C9E03BC54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171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423CB-70D0-461A-9227-5037AEA126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8170E7-C86B-4DED-9A1F-1319417CB9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E7B667-0CD7-43F4-9A42-49130D7662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B0BBF6-56A8-4795-A076-764B8BDF8E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DB5927-C6E8-4355-B829-B05074FE8B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F10AF5-435F-44D7-B786-0232AC014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2D4B9F-B350-46C1-A0BE-012EDE77A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ADB80C-544D-47FF-8F31-44D36FF95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91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2548C7-A126-4E6B-80B2-AEE5799F48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EF4820-5315-4AA9-A322-2DC250B5E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8F0B12-322F-477D-905C-0E40577BB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2AE48A-FB98-4258-B1BF-96F7E3EBF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455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5FAE73-ACD5-4B1A-A0A8-5ED8761AC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F6F840-71B3-442A-BE0B-413141BA9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EA3F1F-E722-4E56-A3F3-039B4AFB3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692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5B120-66F0-435A-8F72-6D66B681F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1D7251-DA7F-4A89-A63B-6B51920521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1DC855-9197-473B-A101-37F7181718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DF1873-DAC3-40DC-9F66-CE56A8568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03D965-BFA9-4982-BDFF-EFF743F70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763BC9-0970-4817-8A91-46B9C9F61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139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6D578-9C83-4D27-A6D3-9282589E2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B01B3D-D130-4B45-AEE9-80FA6E7486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556AAF-FBCF-46EA-8203-C2F1269506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B53B86-A698-4C2C-8036-7D51727E8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590CD7-AA79-415E-A6B8-BAF923A5A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BEB3D4-B7EB-48CA-9CBA-E8CF0756F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573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BA0BDF-7381-4491-9125-D587CCDF4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44F247-7174-479B-B70D-DF9F486A43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69BCDD-B4B6-42D0-81F7-655CEB8969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D6104-A606-4B35-8D15-EF2B27A64088}" type="datetimeFigureOut">
              <a:rPr lang="en-US" smtClean="0"/>
              <a:t>4/2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3B1F2-30F3-4600-B25C-FC92C07F37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EB88E3-1DFC-4DEE-B045-429976DBB6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C0B30-9927-49BF-B801-AF3209661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641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mp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mp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E02BE53-DEA3-4C06-B8F6-92964F6217A9}"/>
              </a:ext>
            </a:extLst>
          </p:cNvPr>
          <p:cNvGrpSpPr/>
          <p:nvPr/>
        </p:nvGrpSpPr>
        <p:grpSpPr>
          <a:xfrm>
            <a:off x="2312170" y="334061"/>
            <a:ext cx="7567660" cy="6156776"/>
            <a:chOff x="2617739" y="0"/>
            <a:chExt cx="6956521" cy="574486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03CD36B-8C37-4335-A0FA-2E761B7AD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7740" y="0"/>
              <a:ext cx="6956520" cy="5314091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CD9E8BD-F66C-408E-B05E-B57C130742A5}"/>
                </a:ext>
              </a:extLst>
            </p:cNvPr>
            <p:cNvSpPr txBox="1"/>
            <p:nvPr/>
          </p:nvSpPr>
          <p:spPr>
            <a:xfrm>
              <a:off x="2617739" y="5314091"/>
              <a:ext cx="6956519" cy="430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1. IGHV3 family hotspot profiles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Distribution of AID overlapping WCGW hotspots and </a:t>
              </a:r>
              <a:r>
                <a:rPr lang="en-US" sz="1200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Polη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WA/TW hotspots for all human IGHV3 family genes, the largest family in human.</a:t>
              </a:r>
              <a:endParaRPr lang="en-US" sz="11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313087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6DC7D4F-6BD1-48E5-A71C-B787620F7A4B}"/>
              </a:ext>
            </a:extLst>
          </p:cNvPr>
          <p:cNvGrpSpPr/>
          <p:nvPr/>
        </p:nvGrpSpPr>
        <p:grpSpPr>
          <a:xfrm>
            <a:off x="2172970" y="233677"/>
            <a:ext cx="7846060" cy="6205980"/>
            <a:chOff x="2172970" y="0"/>
            <a:chExt cx="7846060" cy="620598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DE6ABC8-7594-4319-840C-7CA1A81104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2970" y="0"/>
              <a:ext cx="7846060" cy="574431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7FD5658-1A85-4223-BDCC-C5549ED34057}"/>
                </a:ext>
              </a:extLst>
            </p:cNvPr>
            <p:cNvSpPr txBox="1"/>
            <p:nvPr/>
          </p:nvSpPr>
          <p:spPr>
            <a:xfrm>
              <a:off x="2172970" y="5744315"/>
              <a:ext cx="78460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2. Non-IGHV3 family hotspot profiles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Same as Figure S1 but here showing profiles for all human genes not in the IGHV3 family.</a:t>
              </a:r>
              <a:endParaRPr lang="en-US" sz="11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0165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6B5AFD0-6B70-45DC-9376-609C235E1E5A}"/>
              </a:ext>
            </a:extLst>
          </p:cNvPr>
          <p:cNvGrpSpPr/>
          <p:nvPr/>
        </p:nvGrpSpPr>
        <p:grpSpPr>
          <a:xfrm>
            <a:off x="3967162" y="-9615"/>
            <a:ext cx="4257675" cy="6877229"/>
            <a:chOff x="3252106" y="0"/>
            <a:chExt cx="4257675" cy="6877229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653C41D-CE5D-455B-819E-53F69478148E}"/>
                </a:ext>
              </a:extLst>
            </p:cNvPr>
            <p:cNvSpPr txBox="1"/>
            <p:nvPr/>
          </p:nvSpPr>
          <p:spPr>
            <a:xfrm>
              <a:off x="3252106" y="5676900"/>
              <a:ext cx="4257675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3. Extended hotspot signature distribution profile for IGHV1-69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(A) Plot is identical to Figure 1A (profile for WGCW only). (B) Hotspot distribution for </a:t>
              </a:r>
              <a:r>
                <a:rPr lang="en-US" sz="1200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Polη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WA/TW hotspots. (C) Co-localization (signature) of AID and Pol</a:t>
              </a:r>
              <a:r>
                <a:rPr lang="el-GR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η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hotspots. The dotted </a:t>
              </a:r>
              <a:r>
                <a:rPr lang="en-US" sz="1200">
                  <a:latin typeface="Times New Roman" panose="02020603050405020304" pitchFamily="18" charset="0"/>
                  <a:ea typeface="Times New Roman" panose="02020603050405020304" pitchFamily="18" charset="0"/>
                </a:rPr>
                <a:t>line indicates 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the threshold used for discretization and the binomial tests.</a:t>
              </a:r>
              <a:endParaRPr lang="en-US" sz="12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pic>
          <p:nvPicPr>
            <p:cNvPr id="8" name="Picture 7" descr="A close up of a map&#10;&#10;Description automatically generated">
              <a:extLst>
                <a:ext uri="{FF2B5EF4-FFF2-40B4-BE49-F238E27FC236}">
                  <a16:creationId xmlns:a16="http://schemas.microsoft.com/office/drawing/2014/main" id="{28A3BAB7-93E8-497B-B948-7B783919FF1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2106" y="0"/>
              <a:ext cx="4257675" cy="56769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31078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E29C022-3BDE-4118-8A5A-791612CBAC98}"/>
              </a:ext>
            </a:extLst>
          </p:cNvPr>
          <p:cNvGrpSpPr/>
          <p:nvPr/>
        </p:nvGrpSpPr>
        <p:grpSpPr>
          <a:xfrm>
            <a:off x="1793318" y="461433"/>
            <a:ext cx="8605363" cy="5833954"/>
            <a:chOff x="1793318" y="461433"/>
            <a:chExt cx="8605363" cy="58339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D72A912-B87F-4839-85AD-FD0AD8928B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3318" y="461433"/>
              <a:ext cx="8605363" cy="5428778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89401F7-098E-4C54-8CEE-31CC61EFF20B}"/>
                </a:ext>
              </a:extLst>
            </p:cNvPr>
            <p:cNvSpPr txBox="1"/>
            <p:nvPr/>
          </p:nvSpPr>
          <p:spPr>
            <a:xfrm>
              <a:off x="1793318" y="5890211"/>
              <a:ext cx="8605363" cy="4051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4. PCA analysis for genes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Format follows that of Figure 2, testing different window sizes for AID overlapping hotspots.</a:t>
              </a:r>
              <a:endParaRPr lang="en-US" sz="11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073770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7CD9D37-3DA3-42E4-9354-521C07D8ABB5}"/>
              </a:ext>
            </a:extLst>
          </p:cNvPr>
          <p:cNvGrpSpPr/>
          <p:nvPr/>
        </p:nvGrpSpPr>
        <p:grpSpPr>
          <a:xfrm>
            <a:off x="3336326" y="145142"/>
            <a:ext cx="5519348" cy="6606228"/>
            <a:chOff x="3336326" y="145142"/>
            <a:chExt cx="5519348" cy="6606228"/>
          </a:xfrm>
        </p:grpSpPr>
        <p:pic>
          <p:nvPicPr>
            <p:cNvPr id="3" name="Picture 2" descr="A close up of a map&#10;&#10;Description automatically generated">
              <a:extLst>
                <a:ext uri="{FF2B5EF4-FFF2-40B4-BE49-F238E27FC236}">
                  <a16:creationId xmlns:a16="http://schemas.microsoft.com/office/drawing/2014/main" id="{1C019BE9-33C4-4377-AD32-F2A7F8A9D0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36326" y="145142"/>
              <a:ext cx="5519348" cy="559056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5A2E62B-928E-4AFD-8F9C-A1988A2E4601}"/>
                </a:ext>
              </a:extLst>
            </p:cNvPr>
            <p:cNvSpPr txBox="1"/>
            <p:nvPr/>
          </p:nvSpPr>
          <p:spPr>
            <a:xfrm>
              <a:off x="3336326" y="5735707"/>
              <a:ext cx="5519348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5. Sub-region comparison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Averaged profiles for sites within each of the three color-delimited areas in Figure 2 (FW1, FW3, CDR1, CDR2) were calculated for each IGHV gene, then compared using linear regression. (A) Comparison of FW1 and FW3 sites considered separately. (B) Comparison of CDR2 sub-region with merged FW1/3. (C) CDR1 vs CDR2. (D) CDR1 vs merged FW1/3.</a:t>
              </a:r>
              <a:endParaRPr lang="en-US" sz="11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71374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BED198D4-1ABE-4512-AE9F-AD21FB47DE55}"/>
              </a:ext>
            </a:extLst>
          </p:cNvPr>
          <p:cNvGrpSpPr/>
          <p:nvPr/>
        </p:nvGrpSpPr>
        <p:grpSpPr>
          <a:xfrm>
            <a:off x="1814822" y="644951"/>
            <a:ext cx="8562355" cy="5568097"/>
            <a:chOff x="1803393" y="419100"/>
            <a:chExt cx="8562355" cy="5568097"/>
          </a:xfrm>
        </p:grpSpPr>
        <p:pic>
          <p:nvPicPr>
            <p:cNvPr id="3" name="Picture 2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C6F32A93-01EB-4E94-A27D-640156061A2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8967" y="419100"/>
              <a:ext cx="8526781" cy="47371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B289DB7-7315-4D20-ADC7-BED4BC685885}"/>
                </a:ext>
              </a:extLst>
            </p:cNvPr>
            <p:cNvSpPr txBox="1"/>
            <p:nvPr/>
          </p:nvSpPr>
          <p:spPr>
            <a:xfrm>
              <a:off x="1803393" y="5156200"/>
              <a:ext cx="854964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6. Identifying co-localized WGCW/WA hotspot regions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Site-by-site calculation of the average number of WGCW/WA hotspots found in a window of size 31 (+/- 15 </a:t>
              </a:r>
              <a:r>
                <a:rPr lang="en-US" sz="1200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nt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around each site) for (A) IGHV3-21*01, IGHV3-30*01, and IGHV3-48*01 (gray arrows in Figure 3A); and for (B) IGHV3-64*01 and IGHV3-73*01 </a:t>
              </a:r>
              <a:r>
                <a:rPr lang="en-US" sz="1200">
                  <a:latin typeface="Times New Roman" panose="02020603050405020304" pitchFamily="18" charset="0"/>
                  <a:ea typeface="Times New Roman" panose="02020603050405020304" pitchFamily="18" charset="0"/>
                </a:rPr>
                <a:t>(black 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arrows in Figure 4A). The bold line indicates the average across the select IGHV genes and is colored according to sub-region. The shaded region represents +/- 1 standard deviation at each site.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3531599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1E8984A-F3D6-4B28-BCB3-B39792A72ACE}"/>
              </a:ext>
            </a:extLst>
          </p:cNvPr>
          <p:cNvGrpSpPr/>
          <p:nvPr/>
        </p:nvGrpSpPr>
        <p:grpSpPr>
          <a:xfrm>
            <a:off x="2650067" y="0"/>
            <a:ext cx="7671423" cy="6101475"/>
            <a:chOff x="2650067" y="0"/>
            <a:chExt cx="7671423" cy="610147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7F0D042-E19C-4480-A04C-27121D5A82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50067" y="0"/>
              <a:ext cx="7671423" cy="5824476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4FA51D7-1A5A-47F5-A40C-760ABBFC48B3}"/>
                </a:ext>
              </a:extLst>
            </p:cNvPr>
            <p:cNvSpPr txBox="1"/>
            <p:nvPr/>
          </p:nvSpPr>
          <p:spPr>
            <a:xfrm>
              <a:off x="2650067" y="5824476"/>
              <a:ext cx="7671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7. Motif distribution for non-functional genes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. Same as Figures S1 and S2 but with all non-functional genes.</a:t>
              </a:r>
              <a:endParaRPr lang="en-US" sz="12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960977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531D779-B44F-42DD-B249-018A3619CA56}"/>
              </a:ext>
            </a:extLst>
          </p:cNvPr>
          <p:cNvGrpSpPr/>
          <p:nvPr/>
        </p:nvGrpSpPr>
        <p:grpSpPr>
          <a:xfrm>
            <a:off x="3165227" y="77529"/>
            <a:ext cx="5861546" cy="6721136"/>
            <a:chOff x="3165227" y="77529"/>
            <a:chExt cx="5861546" cy="672113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482225B-0800-47B9-B6F5-97F5704E97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5227" y="77529"/>
              <a:ext cx="5861546" cy="5890139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586FE7A-88A2-49DC-82AE-2DA546531138}"/>
                </a:ext>
              </a:extLst>
            </p:cNvPr>
            <p:cNvSpPr txBox="1"/>
            <p:nvPr/>
          </p:nvSpPr>
          <p:spPr>
            <a:xfrm>
              <a:off x="3165227" y="5967668"/>
              <a:ext cx="586154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8. WGCW hotspot variation in the IGHV1, IGHV3 and IGHV4 families.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(A) Standard deviation of the WGCW profiles for each of the three IGHV families on a site-by-site basis. (B) Averages of the data in (A) within each of the CDR or FW subregions. CDR1 and CDR2 are shown with gray background.</a:t>
              </a:r>
              <a:endParaRPr lang="en-US" sz="1200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38116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413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hy Tang</dc:creator>
  <cp:lastModifiedBy>Cathy Tang</cp:lastModifiedBy>
  <cp:revision>64</cp:revision>
  <dcterms:created xsi:type="dcterms:W3CDTF">2019-09-24T19:28:01Z</dcterms:created>
  <dcterms:modified xsi:type="dcterms:W3CDTF">2020-04-23T17:48:21Z</dcterms:modified>
</cp:coreProperties>
</file>